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50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1356" y="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dhya\AppData\Roaming\Microsoft\Excel\Consolidated%20Repeats%20data%20(version%201).xlsb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dhya\AppData\Roaming\Microsoft\Excel\Consolidated%20Repeats%20data%20(version%201).xlsb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lineChart>
        <c:grouping val="standard"/>
        <c:ser>
          <c:idx val="0"/>
          <c:order val="0"/>
          <c:tx>
            <c:strRef>
              <c:f>Consolidated!$E$4</c:f>
              <c:strCache>
                <c:ptCount val="1"/>
                <c:pt idx="0">
                  <c:v>MAGGY_I-int</c:v>
                </c:pt>
              </c:strCache>
            </c:strRef>
          </c:tx>
          <c:marker>
            <c:symbol val="none"/>
          </c:marker>
          <c:cat>
            <c:numRef>
              <c:f>Consolidated!$B$9:$B$25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Consolidated!$E$9:$E$25</c:f>
              <c:numCache>
                <c:formatCode>General</c:formatCode>
                <c:ptCount val="17"/>
                <c:pt idx="0">
                  <c:v>4.734602495306742</c:v>
                </c:pt>
                <c:pt idx="1">
                  <c:v>13.393803611908355</c:v>
                </c:pt>
                <c:pt idx="2">
                  <c:v>16.629880477965056</c:v>
                </c:pt>
                <c:pt idx="3">
                  <c:v>13.24308947367285</c:v>
                </c:pt>
                <c:pt idx="4">
                  <c:v>9.2843047748811411</c:v>
                </c:pt>
                <c:pt idx="5">
                  <c:v>32.332059740401213</c:v>
                </c:pt>
                <c:pt idx="6">
                  <c:v>6.2208814469295755</c:v>
                </c:pt>
                <c:pt idx="7">
                  <c:v>2.4312116733607967</c:v>
                </c:pt>
                <c:pt idx="8">
                  <c:v>0.76350957779425033</c:v>
                </c:pt>
                <c:pt idx="9">
                  <c:v>0.29801274577589765</c:v>
                </c:pt>
                <c:pt idx="10">
                  <c:v>0.22551733751074346</c:v>
                </c:pt>
                <c:pt idx="11">
                  <c:v>0.21804009463789462</c:v>
                </c:pt>
                <c:pt idx="12">
                  <c:v>0.11514338613251461</c:v>
                </c:pt>
                <c:pt idx="13">
                  <c:v>6.6802857106811803E-2</c:v>
                </c:pt>
                <c:pt idx="14">
                  <c:v>2.5970341500759688E-2</c:v>
                </c:pt>
                <c:pt idx="15">
                  <c:v>1.2615924188757621E-2</c:v>
                </c:pt>
                <c:pt idx="16">
                  <c:v>4.5540409266734789E-3</c:v>
                </c:pt>
              </c:numCache>
            </c:numRef>
          </c:val>
        </c:ser>
        <c:ser>
          <c:idx val="1"/>
          <c:order val="1"/>
          <c:tx>
            <c:strRef>
              <c:f>Consolidated!$F$4</c:f>
              <c:strCache>
                <c:ptCount val="1"/>
                <c:pt idx="0">
                  <c:v>MAGGY_LTR</c:v>
                </c:pt>
              </c:strCache>
            </c:strRef>
          </c:tx>
          <c:marker>
            <c:symbol val="none"/>
          </c:marker>
          <c:cat>
            <c:numRef>
              <c:f>Consolidated!$B$9:$B$25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Consolidated!$F$9:$F$25</c:f>
              <c:numCache>
                <c:formatCode>General</c:formatCode>
                <c:ptCount val="17"/>
                <c:pt idx="0">
                  <c:v>2.5563987480068566</c:v>
                </c:pt>
                <c:pt idx="1">
                  <c:v>13.202031536053859</c:v>
                </c:pt>
                <c:pt idx="2">
                  <c:v>12.150091537235006</c:v>
                </c:pt>
                <c:pt idx="3">
                  <c:v>14.575090060827998</c:v>
                </c:pt>
                <c:pt idx="4">
                  <c:v>35.241097265694037</c:v>
                </c:pt>
                <c:pt idx="5">
                  <c:v>10.458867300537412</c:v>
                </c:pt>
                <c:pt idx="6">
                  <c:v>5.7720132286068626</c:v>
                </c:pt>
                <c:pt idx="7">
                  <c:v>4.0859564164648905</c:v>
                </c:pt>
                <c:pt idx="8">
                  <c:v>1.1560266934388472</c:v>
                </c:pt>
                <c:pt idx="9">
                  <c:v>0.36319612590799111</c:v>
                </c:pt>
                <c:pt idx="10">
                  <c:v>0.26058583830390381</c:v>
                </c:pt>
                <c:pt idx="11">
                  <c:v>7.5296757810193404E-2</c:v>
                </c:pt>
                <c:pt idx="12">
                  <c:v>4.3554006968641132E-2</c:v>
                </c:pt>
                <c:pt idx="13">
                  <c:v>3.3957361365381203E-2</c:v>
                </c:pt>
                <c:pt idx="14">
                  <c:v>1.9931494714462969E-2</c:v>
                </c:pt>
                <c:pt idx="15">
                  <c:v>2.9528140317722808E-3</c:v>
                </c:pt>
                <c:pt idx="16">
                  <c:v>2.9528140317722808E-3</c:v>
                </c:pt>
              </c:numCache>
            </c:numRef>
          </c:val>
        </c:ser>
        <c:ser>
          <c:idx val="2"/>
          <c:order val="2"/>
          <c:tx>
            <c:strRef>
              <c:f>Consolidated!$G$4</c:f>
              <c:strCache>
                <c:ptCount val="1"/>
                <c:pt idx="0">
                  <c:v>GYMAG1_I-int</c:v>
                </c:pt>
              </c:strCache>
            </c:strRef>
          </c:tx>
          <c:marker>
            <c:symbol val="none"/>
          </c:marker>
          <c:cat>
            <c:numRef>
              <c:f>Consolidated!$B$9:$B$25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Consolidated!$G$9:$G$25</c:f>
              <c:numCache>
                <c:formatCode>General</c:formatCode>
                <c:ptCount val="17"/>
                <c:pt idx="0">
                  <c:v>6.3307594374826373</c:v>
                </c:pt>
                <c:pt idx="1">
                  <c:v>17.343310228431189</c:v>
                </c:pt>
                <c:pt idx="2">
                  <c:v>20.303940841044451</c:v>
                </c:pt>
                <c:pt idx="3">
                  <c:v>17.552571375611564</c:v>
                </c:pt>
                <c:pt idx="4">
                  <c:v>12.445184798567874</c:v>
                </c:pt>
                <c:pt idx="5">
                  <c:v>14.581209422117293</c:v>
                </c:pt>
                <c:pt idx="6">
                  <c:v>7.0800021462681784</c:v>
                </c:pt>
                <c:pt idx="7">
                  <c:v>2.0233455442984876</c:v>
                </c:pt>
                <c:pt idx="8">
                  <c:v>0.74680376767622569</c:v>
                </c:pt>
                <c:pt idx="9">
                  <c:v>0.60315013633681003</c:v>
                </c:pt>
                <c:pt idx="10">
                  <c:v>0.39096225982527566</c:v>
                </c:pt>
                <c:pt idx="11">
                  <c:v>0.25413766359197493</c:v>
                </c:pt>
                <c:pt idx="12">
                  <c:v>0.17340871287321896</c:v>
                </c:pt>
                <c:pt idx="13">
                  <c:v>0.1034111030355061</c:v>
                </c:pt>
                <c:pt idx="14">
                  <c:v>4.8291033964693912E-2</c:v>
                </c:pt>
                <c:pt idx="15">
                  <c:v>9.755764437311942E-3</c:v>
                </c:pt>
                <c:pt idx="16">
                  <c:v>9.755764437311942E-3</c:v>
                </c:pt>
              </c:numCache>
            </c:numRef>
          </c:val>
        </c:ser>
        <c:ser>
          <c:idx val="3"/>
          <c:order val="3"/>
          <c:tx>
            <c:strRef>
              <c:f>Consolidated!$H$4</c:f>
              <c:strCache>
                <c:ptCount val="1"/>
                <c:pt idx="0">
                  <c:v>GYMAG2_I-int</c:v>
                </c:pt>
              </c:strCache>
            </c:strRef>
          </c:tx>
          <c:marker>
            <c:symbol val="none"/>
          </c:marker>
          <c:cat>
            <c:numRef>
              <c:f>Consolidated!$B$9:$B$25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Consolidated!$H$9:$H$25</c:f>
              <c:numCache>
                <c:formatCode>General</c:formatCode>
                <c:ptCount val="17"/>
                <c:pt idx="0">
                  <c:v>4.4158871145547893</c:v>
                </c:pt>
                <c:pt idx="1">
                  <c:v>20.321899902359128</c:v>
                </c:pt>
                <c:pt idx="2">
                  <c:v>17.285583797914889</c:v>
                </c:pt>
                <c:pt idx="3">
                  <c:v>34.117610003464563</c:v>
                </c:pt>
                <c:pt idx="4">
                  <c:v>11.650760653878862</c:v>
                </c:pt>
                <c:pt idx="5">
                  <c:v>4.9607861664934285</c:v>
                </c:pt>
                <c:pt idx="6">
                  <c:v>5.0836246810923376</c:v>
                </c:pt>
                <c:pt idx="7">
                  <c:v>1.3701218936029478</c:v>
                </c:pt>
                <c:pt idx="8">
                  <c:v>0.53230022992850168</c:v>
                </c:pt>
                <c:pt idx="9">
                  <c:v>0.15433556962424014</c:v>
                </c:pt>
                <c:pt idx="10">
                  <c:v>8.189234306592362E-2</c:v>
                </c:pt>
                <c:pt idx="11">
                  <c:v>2.5197644020284148E-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</c:numCache>
            </c:numRef>
          </c:val>
        </c:ser>
        <c:marker val="1"/>
        <c:axId val="65248640"/>
        <c:axId val="59679872"/>
      </c:lineChart>
      <c:catAx>
        <c:axId val="65248640"/>
        <c:scaling>
          <c:orientation val="minMax"/>
        </c:scaling>
        <c:axPos val="b"/>
        <c:numFmt formatCode="General" sourceLinked="1"/>
        <c:tickLblPos val="nextTo"/>
        <c:crossAx val="59679872"/>
        <c:crosses val="autoZero"/>
        <c:auto val="1"/>
        <c:lblAlgn val="ctr"/>
        <c:lblOffset val="100"/>
      </c:catAx>
      <c:valAx>
        <c:axId val="59679872"/>
        <c:scaling>
          <c:orientation val="minMax"/>
        </c:scaling>
        <c:axPos val="l"/>
        <c:majorGridlines/>
        <c:numFmt formatCode="General" sourceLinked="1"/>
        <c:tickLblPos val="nextTo"/>
        <c:crossAx val="65248640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sz="55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spPr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13474391038224667"/>
          <c:y val="4.2378608923884523E-2"/>
          <c:w val="0.53785689651953938"/>
          <c:h val="0.72874015748031729"/>
        </c:manualLayout>
      </c:layout>
      <c:lineChart>
        <c:grouping val="standard"/>
        <c:ser>
          <c:idx val="0"/>
          <c:order val="0"/>
          <c:tx>
            <c:strRef>
              <c:f>Consolidated!$A$39</c:f>
              <c:strCache>
                <c:ptCount val="1"/>
                <c:pt idx="0">
                  <c:v>MAGGY_I-int</c:v>
                </c:pt>
              </c:strCache>
            </c:strRef>
          </c:tx>
          <c:marker>
            <c:symbol val="none"/>
          </c:marker>
          <c:cat>
            <c:strRef>
              <c:f>Consolidated!$S$37:$W$37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Consolidated!$S$39:$W$39</c:f>
              <c:numCache>
                <c:formatCode>General</c:formatCode>
                <c:ptCount val="5"/>
                <c:pt idx="0">
                  <c:v>14.537452524892602</c:v>
                </c:pt>
                <c:pt idx="1">
                  <c:v>24.018904193133181</c:v>
                </c:pt>
                <c:pt idx="2">
                  <c:v>24.944297617651952</c:v>
                </c:pt>
                <c:pt idx="3">
                  <c:v>21.690558457730965</c:v>
                </c:pt>
                <c:pt idx="4">
                  <c:v>14.808787206591306</c:v>
                </c:pt>
              </c:numCache>
            </c:numRef>
          </c:val>
        </c:ser>
        <c:ser>
          <c:idx val="1"/>
          <c:order val="1"/>
          <c:tx>
            <c:strRef>
              <c:f>Consolidated!$A$40</c:f>
              <c:strCache>
                <c:ptCount val="1"/>
                <c:pt idx="0">
                  <c:v>MAGGY_LTR</c:v>
                </c:pt>
              </c:strCache>
            </c:strRef>
          </c:tx>
          <c:marker>
            <c:symbol val="none"/>
          </c:marker>
          <c:cat>
            <c:strRef>
              <c:f>Consolidated!$S$37:$W$37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Consolidated!$S$40:$W$40</c:f>
              <c:numCache>
                <c:formatCode>General</c:formatCode>
                <c:ptCount val="5"/>
                <c:pt idx="0">
                  <c:v>24.095700702769669</c:v>
                </c:pt>
                <c:pt idx="1">
                  <c:v>27.601429161991376</c:v>
                </c:pt>
                <c:pt idx="2">
                  <c:v>16.685613890037107</c:v>
                </c:pt>
                <c:pt idx="3">
                  <c:v>14.672532923876474</c:v>
                </c:pt>
                <c:pt idx="4">
                  <c:v>16.944723321325124</c:v>
                </c:pt>
              </c:numCache>
            </c:numRef>
          </c:val>
        </c:ser>
        <c:ser>
          <c:idx val="2"/>
          <c:order val="2"/>
          <c:tx>
            <c:strRef>
              <c:f>Consolidated!$A$41</c:f>
              <c:strCache>
                <c:ptCount val="1"/>
                <c:pt idx="0">
                  <c:v>GYMAG1_I-int</c:v>
                </c:pt>
              </c:strCache>
            </c:strRef>
          </c:tx>
          <c:marker>
            <c:symbol val="none"/>
          </c:marker>
          <c:cat>
            <c:strRef>
              <c:f>Consolidated!$S$37:$W$37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Consolidated!$S$41:$W$41</c:f>
              <c:numCache>
                <c:formatCode>General</c:formatCode>
                <c:ptCount val="5"/>
                <c:pt idx="0">
                  <c:v>12.057880950406572</c:v>
                </c:pt>
                <c:pt idx="1">
                  <c:v>16.627237118732531</c:v>
                </c:pt>
                <c:pt idx="2">
                  <c:v>18.456930738950376</c:v>
                </c:pt>
                <c:pt idx="3">
                  <c:v>24.127956606359795</c:v>
                </c:pt>
                <c:pt idx="4">
                  <c:v>28.729994585550727</c:v>
                </c:pt>
              </c:numCache>
            </c:numRef>
          </c:val>
        </c:ser>
        <c:ser>
          <c:idx val="3"/>
          <c:order val="3"/>
          <c:tx>
            <c:strRef>
              <c:f>Consolidated!$A$42</c:f>
              <c:strCache>
                <c:ptCount val="1"/>
                <c:pt idx="0">
                  <c:v>GYMAG2_I-int</c:v>
                </c:pt>
              </c:strCache>
            </c:strRef>
          </c:tx>
          <c:marker>
            <c:symbol val="none"/>
          </c:marker>
          <c:cat>
            <c:strRef>
              <c:f>Consolidated!$S$37:$W$37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Consolidated!$S$42:$W$42</c:f>
              <c:numCache>
                <c:formatCode>General</c:formatCode>
                <c:ptCount val="5"/>
                <c:pt idx="0">
                  <c:v>2.4095247094396672</c:v>
                </c:pt>
                <c:pt idx="1">
                  <c:v>4.8662950014173694</c:v>
                </c:pt>
                <c:pt idx="2">
                  <c:v>3.9150839396516348</c:v>
                </c:pt>
                <c:pt idx="3">
                  <c:v>53.856814387854726</c:v>
                </c:pt>
                <c:pt idx="4">
                  <c:v>34.952281961636309</c:v>
                </c:pt>
              </c:numCache>
            </c:numRef>
          </c:val>
        </c:ser>
        <c:marker val="1"/>
        <c:axId val="59984512"/>
        <c:axId val="59998592"/>
      </c:lineChart>
      <c:catAx>
        <c:axId val="59984512"/>
        <c:scaling>
          <c:orientation val="minMax"/>
        </c:scaling>
        <c:axPos val="b"/>
        <c:tickLblPos val="nextTo"/>
        <c:crossAx val="59998592"/>
        <c:crosses val="autoZero"/>
        <c:auto val="1"/>
        <c:lblAlgn val="ctr"/>
        <c:lblOffset val="100"/>
      </c:catAx>
      <c:valAx>
        <c:axId val="59998592"/>
        <c:scaling>
          <c:orientation val="minMax"/>
        </c:scaling>
        <c:axPos val="l"/>
        <c:majorGridlines/>
        <c:numFmt formatCode="General" sourceLinked="1"/>
        <c:tickLblPos val="nextTo"/>
        <c:crossAx val="599845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4740489064131101"/>
          <c:y val="0.33217410323709701"/>
          <c:w val="0.32347908050991486"/>
          <c:h val="0.33565179352581065"/>
        </c:manualLayout>
      </c:layout>
      <c:txPr>
        <a:bodyPr/>
        <a:lstStyle/>
        <a:p>
          <a:pPr>
            <a:defRPr sz="55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spPr>
    <a:ln>
      <a:noFill/>
    </a:ln>
  </c:sp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6CD96B-B903-4B94-92E8-9B52997C2A10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9EEC92-05C9-4FBE-856E-CF31AB3165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47553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2D626-70B3-4B8D-971F-A5D6662CD8BC}" type="datetimeFigureOut">
              <a:rPr lang="en-US" smtClean="0"/>
              <a:pPr/>
              <a:t>8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546554" y="1447800"/>
            <a:ext cx="6392945" cy="4719758"/>
            <a:chOff x="546554" y="1447800"/>
            <a:chExt cx="6392945" cy="4719758"/>
          </a:xfrm>
        </p:grpSpPr>
        <p:graphicFrame>
          <p:nvGraphicFramePr>
            <p:cNvPr id="3" name="Chart 2"/>
            <p:cNvGraphicFramePr>
              <a:graphicFrameLocks noChangeAspect="1"/>
            </p:cNvGraphicFramePr>
            <p:nvPr/>
          </p:nvGraphicFramePr>
          <p:xfrm>
            <a:off x="838199" y="1752600"/>
            <a:ext cx="30353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3"/>
            <p:cNvGraphicFramePr>
              <a:graphicFrameLocks noChangeAspect="1"/>
            </p:cNvGraphicFramePr>
            <p:nvPr/>
          </p:nvGraphicFramePr>
          <p:xfrm>
            <a:off x="3886198" y="4338758"/>
            <a:ext cx="3053301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l="4375" t="21000" r="84375" b="59000"/>
            <a:stretch>
              <a:fillRect/>
            </a:stretch>
          </p:blipFill>
          <p:spPr bwMode="auto">
            <a:xfrm>
              <a:off x="4343400" y="1905000"/>
              <a:ext cx="1371600" cy="152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" name="TextBox 6"/>
            <p:cNvSpPr txBox="1"/>
            <p:nvPr/>
          </p:nvSpPr>
          <p:spPr>
            <a:xfrm>
              <a:off x="636760" y="1582579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(A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065760" y="1582579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(B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09600" y="3886200"/>
              <a:ext cx="3642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(C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889498" y="3886200"/>
              <a:ext cx="3642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(D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-126176" y="2259777"/>
              <a:ext cx="18393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s RNA Abundance (%)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143000" y="3518356"/>
              <a:ext cx="17526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Small RNA length (</a:t>
              </a:r>
              <a:r>
                <a:rPr lang="en-US" sz="800" dirty="0" err="1" smtClean="0">
                  <a:latin typeface="Arial" pitchFamily="34" charset="0"/>
                  <a:cs typeface="Arial" pitchFamily="34" charset="0"/>
                </a:rPr>
                <a:t>nt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3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 l="6772" t="46569" r="53727" b="26470"/>
            <a:stretch>
              <a:fillRect/>
            </a:stretch>
          </p:blipFill>
          <p:spPr bwMode="auto">
            <a:xfrm>
              <a:off x="685800" y="4191000"/>
              <a:ext cx="2667000" cy="1676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6" name="TextBox 15"/>
            <p:cNvSpPr txBox="1"/>
            <p:nvPr/>
          </p:nvSpPr>
          <p:spPr>
            <a:xfrm rot="16200000">
              <a:off x="2921824" y="4826827"/>
              <a:ext cx="18393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sRNA Abundance (%)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790700" y="5804356"/>
              <a:ext cx="1066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Repeat size(kb)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39378" y="4921478"/>
              <a:ext cx="1229798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sRNA Abundance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11285008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68</TotalTime>
  <Words>30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AN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dhya</dc:creator>
  <cp:lastModifiedBy>vidhya</cp:lastModifiedBy>
  <cp:revision>282</cp:revision>
  <dcterms:created xsi:type="dcterms:W3CDTF">2011-10-06T15:16:14Z</dcterms:created>
  <dcterms:modified xsi:type="dcterms:W3CDTF">2012-08-06T14:24:48Z</dcterms:modified>
</cp:coreProperties>
</file>